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056C3BE-53F0-414E-B478-48B24620B256}" v="1" dt="2019-04-10T10:32:43.722"/>
    <p1510:client id="{72CD9943-0976-384F-B47A-8FACDC6D8CBD}" v="1" dt="2019-04-10T10:11:17.5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3129"/>
  </p:normalViewPr>
  <p:slideViewPr>
    <p:cSldViewPr snapToGrid="0" snapToObjects="1">
      <p:cViewPr varScale="1">
        <p:scale>
          <a:sx n="82" d="100"/>
          <a:sy n="82" d="100"/>
        </p:scale>
        <p:origin x="3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borah Lipski" userId="cd64e408eec4740c" providerId="LiveId" clId="{72CD9943-0976-384F-B47A-8FACDC6D8CBD}"/>
    <pc:docChg chg="custSel addSld delSld modSld">
      <pc:chgData name="Deborah Lipski" userId="cd64e408eec4740c" providerId="LiveId" clId="{72CD9943-0976-384F-B47A-8FACDC6D8CBD}" dt="2019-04-10T10:11:21.443" v="2" actId="478"/>
      <pc:docMkLst>
        <pc:docMk/>
      </pc:docMkLst>
      <pc:sldChg chg="del">
        <pc:chgData name="Deborah Lipski" userId="cd64e408eec4740c" providerId="LiveId" clId="{72CD9943-0976-384F-B47A-8FACDC6D8CBD}" dt="2019-04-10T10:11:18.595" v="1" actId="2696"/>
        <pc:sldMkLst>
          <pc:docMk/>
          <pc:sldMk cId="2324155290" sldId="256"/>
        </pc:sldMkLst>
      </pc:sldChg>
      <pc:sldChg chg="delSp add">
        <pc:chgData name="Deborah Lipski" userId="cd64e408eec4740c" providerId="LiveId" clId="{72CD9943-0976-384F-B47A-8FACDC6D8CBD}" dt="2019-04-10T10:11:21.443" v="2" actId="478"/>
        <pc:sldMkLst>
          <pc:docMk/>
          <pc:sldMk cId="132887893" sldId="263"/>
        </pc:sldMkLst>
        <pc:spChg chg="del">
          <ac:chgData name="Deborah Lipski" userId="cd64e408eec4740c" providerId="LiveId" clId="{72CD9943-0976-384F-B47A-8FACDC6D8CBD}" dt="2019-04-10T10:11:21.443" v="2" actId="478"/>
          <ac:spMkLst>
            <pc:docMk/>
            <pc:sldMk cId="132887893" sldId="263"/>
            <ac:spMk id="2" creationId="{00000000-0000-0000-0000-000000000000}"/>
          </ac:spMkLst>
        </pc:spChg>
      </pc:sldChg>
    </pc:docChg>
  </pc:docChgLst>
  <pc:docChgLst>
    <pc:chgData name="Deborah Lipski" userId="cd64e408eec4740c" providerId="LiveId" clId="{B056C3BE-53F0-414E-B478-48B24620B256}"/>
    <pc:docChg chg="custSel addSld delSld modSld">
      <pc:chgData name="Deborah Lipski" userId="cd64e408eec4740c" providerId="LiveId" clId="{B056C3BE-53F0-414E-B478-48B24620B256}" dt="2019-04-10T10:32:53.158" v="4" actId="20577"/>
      <pc:docMkLst>
        <pc:docMk/>
      </pc:docMkLst>
      <pc:sldChg chg="del">
        <pc:chgData name="Deborah Lipski" userId="cd64e408eec4740c" providerId="LiveId" clId="{B056C3BE-53F0-414E-B478-48B24620B256}" dt="2019-04-10T10:32:43.088" v="0" actId="2696"/>
        <pc:sldMkLst>
          <pc:docMk/>
          <pc:sldMk cId="132887893" sldId="263"/>
        </pc:sldMkLst>
      </pc:sldChg>
      <pc:sldChg chg="delSp add modNotesTx">
        <pc:chgData name="Deborah Lipski" userId="cd64e408eec4740c" providerId="LiveId" clId="{B056C3BE-53F0-414E-B478-48B24620B256}" dt="2019-04-10T10:32:53.158" v="4" actId="20577"/>
        <pc:sldMkLst>
          <pc:docMk/>
          <pc:sldMk cId="2182116041" sldId="271"/>
        </pc:sldMkLst>
        <pc:spChg chg="del">
          <ac:chgData name="Deborah Lipski" userId="cd64e408eec4740c" providerId="LiveId" clId="{B056C3BE-53F0-414E-B478-48B24620B256}" dt="2019-04-10T10:32:46.653" v="2" actId="478"/>
          <ac:spMkLst>
            <pc:docMk/>
            <pc:sldMk cId="2182116041" sldId="271"/>
            <ac:spMk id="17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847FF7-63EF-1A43-ABC1-381535BC1267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F96DD2-EA4C-FE43-9B96-0F58C6DFB5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4264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4FEA82-2DC0-2D43-A292-D32276698E56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2144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36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0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6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00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041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35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29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2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26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41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577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au 15"/>
          <p:cNvGraphicFramePr>
            <a:graphicFrameLocks noGrp="1"/>
          </p:cNvGraphicFramePr>
          <p:nvPr>
            <p:extLst/>
          </p:nvPr>
        </p:nvGraphicFramePr>
        <p:xfrm>
          <a:off x="858848" y="302372"/>
          <a:ext cx="5450452" cy="2820897"/>
        </p:xfrm>
        <a:graphic>
          <a:graphicData uri="http://schemas.openxmlformats.org/drawingml/2006/table">
            <a:tbl>
              <a:tblPr/>
              <a:tblGrid>
                <a:gridCol w="2658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086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179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89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289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21131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ene ID 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ogFC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DR 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rym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rystallin Mu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030478336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4693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205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nb3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uanine nucleotide binding protein (G protein), beta 3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8660117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79396E-1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k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le Germ Cell Associated Kinase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7003999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29167E-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mpg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terphotoreceptor Matrix Proteoglycan 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656995316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37889E-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cdh1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tocadherin Related 1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1396817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75496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eurod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euronal Differentiation 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47834176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56715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dh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tinol Dehydrogenase 8 (All-Trans)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448153024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4634E-0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rt1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eratine 1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40543178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1349E-0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lc1a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olute Carrier Family 1 Member 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8648528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32015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cy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enylate cyclase 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8215671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53318E-1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8707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lfn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tracellular Leucine Rich Repeat And Fibronectin Type III Domain Containing 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6181093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88813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p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tinitis Pigmentosa RP1 Protein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49323834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28496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g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od Photoreceptor Arrestin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4053760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71949E-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ping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rpin Family G Member 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1019743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74799E-0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169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it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otoreceptor-Associated LRR Superfamily Protein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64249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16467E-1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psm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-Protein Signaling Modulator 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3969770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68496E-0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gs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staglandin-Endoperoxide Synthase 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14015174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41354E-06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md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erile Alpha Motif Domain Containing 1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09311287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2379E-08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169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lco4a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olute Carrier Organic Anion Transporter Family Member 4A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06547844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24792E-09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fx2</a:t>
                      </a:r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lang="fr-BE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gulatory Factor X2</a:t>
                      </a:r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lang="fr-BE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364875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11722E-07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1562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b561</a:t>
                      </a:r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lang="fr-BE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tochrome B561</a:t>
                      </a:r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lang="fr-BE" sz="6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3002862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059051</a:t>
                      </a:r>
                    </a:p>
                  </a:txBody>
                  <a:tcPr marL="5507" marR="5507" marT="550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21160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86</Words>
  <Application>Microsoft Macintosh PowerPoint</Application>
  <PresentationFormat>Format A4 (210 x 297 mm)</PresentationFormat>
  <Paragraphs>11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borah Lipski</dc:creator>
  <cp:lastModifiedBy>Deborah Lipski</cp:lastModifiedBy>
  <cp:revision>1</cp:revision>
  <dcterms:created xsi:type="dcterms:W3CDTF">2019-04-10T10:03:16Z</dcterms:created>
  <dcterms:modified xsi:type="dcterms:W3CDTF">2019-04-10T10:34:24Z</dcterms:modified>
</cp:coreProperties>
</file>